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94660"/>
  </p:normalViewPr>
  <p:slideViewPr>
    <p:cSldViewPr snapToGrid="0">
      <p:cViewPr varScale="1">
        <p:scale>
          <a:sx n="59" d="100"/>
          <a:sy n="59" d="100"/>
        </p:scale>
        <p:origin x="90" y="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AEB14-A0DA-413C-BD32-B9A1E1CB7E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2CCC96-8401-4069-8042-B2E78C532B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01E0E8-1514-4EE2-BCA8-838D4DA45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229414-5F59-4239-BD45-6D0594B10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380BD-C3EC-4DEF-B9E2-BC4DEAA0E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45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F395F-1BB3-454B-A518-0F8F178E7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C5102D-2272-47AD-BA73-D93A0CD031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544D5-EFF4-4F7E-9319-2AC3ACB57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AC522B-6F38-4837-9777-3126D4398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25A47-E766-4651-AAAC-2FA5D797B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988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5A0FC7-B943-4666-85CE-1FE5D92555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8EBD3F-6810-4137-985D-3FDC57B1A6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48989B-7726-431D-82E1-23F570411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E6C540-003E-4498-BE58-D455765BC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BDD52-5E18-4363-A930-4D77328E6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21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AA6D2-7570-4076-B479-A6B9BEAD9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C61CD1-7ECB-4216-9D11-CF8D7728AC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B1CAB2-5D88-4C00-9B1B-E3F5364DA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50248-645A-4032-A470-A0819B91F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A465F6-B1B9-4D11-B36B-78A67B8AA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707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D5746-FAF3-483E-8BB4-78567C1CD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E50D08-8948-4AC6-8556-7435ED4D8C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1659B8-8040-490A-B1BB-D0FE4C18E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5566E5-280D-4E67-BCB1-1D018FB29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D09A0A-09B7-42A7-A1C2-7DB1DAA3B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170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4CEF9-1257-47D5-A187-EA505A0C8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3D7EF2-577A-4A4A-862B-03FA1A63D5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F01A57-A7D1-48EC-A2EC-6406C4FCD7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A4CE64-EBE6-495E-A77C-5D7CBF148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BB6676-166D-475A-9B2E-2E8245262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59B28C-F500-4F3A-9BAB-C4F111593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001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A2923-741A-46E1-80BD-6F43A7411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812135-4947-49B4-A511-19ED2E602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27C3A8-D54C-4CC8-9031-E19F5194EE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29DFBC-40B5-4CE3-8AB3-34111107C0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24113-FED6-4F38-B272-115E7A1FDD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60AFAB-5A3B-4809-9767-327AA79C9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621F0E-D8F3-4CA4-AAAA-B7D1C6DE9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A3F71E-D8EE-496E-8BB4-7251EC1D0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1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A1C7D-DD09-4648-BC83-3DA39B7F7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F36893-7D2D-4EF9-8EB4-A34649997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AE66F7-FF3A-4C56-B145-BBE3CDF0A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03D9AB-787F-45EE-958F-338D84402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57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5EE8ED-27C7-4D6C-A022-CE76D8035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592EA3-D8F1-460E-812B-F48079876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566240-9AF3-499B-B263-417B89D24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542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92915-37EB-4C88-8BB1-1AB1420FE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E5F16-8BED-4C7B-B071-4CD5D847E1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C8CD66-CE7D-4F13-9A17-A17DCCC9C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81079-4924-49D5-8346-465287211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FEFA4-7A71-480E-92F0-8C14442D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0BD7BA-0F90-40D2-A98E-C08E1DC5D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197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0B292-F8BD-4395-95F6-9A400B4CA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EFA1A3-21B2-48A0-8980-62FF3A5AF4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8E64A9-EE47-4397-B748-E0EF85A2AD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2B340C-6BB6-4C9D-AAEB-8A83A8D4F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B32CB6-E7DC-4516-B7E5-3FBD0E36D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67DEE-120E-47AD-A372-3AB014499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087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7AF786-A348-4E78-86E4-8D5D45D2A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6CF09E-FD97-4DF4-84A4-54582CE023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C8C0F-43BD-47D8-A6C2-FE7163C752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58B26-E781-4484-950D-EB55FD3B01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6DE0F-8290-477F-9C5F-84EF8CDD5A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24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411BA72-9B62-498F-8D97-B6A9535536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42" t="1148" r="1" b="-1"/>
          <a:stretch/>
        </p:blipFill>
        <p:spPr>
          <a:xfrm>
            <a:off x="7603236" y="984251"/>
            <a:ext cx="4025728" cy="195541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C412726-CEBA-42BA-B164-17E6826803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167" y="186268"/>
            <a:ext cx="6252633" cy="416842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C8B20C7-A9FA-4F18-9A87-12068AC9D0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3423" y="3365269"/>
            <a:ext cx="6799493" cy="3399747"/>
          </a:xfrm>
          <a:prstGeom prst="rect">
            <a:avLst/>
          </a:prstGeom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B6491B2-6D0E-4D46-BB90-1FFE5380ACF8}"/>
              </a:ext>
            </a:extLst>
          </p:cNvPr>
          <p:cNvCxnSpPr/>
          <p:nvPr/>
        </p:nvCxnSpPr>
        <p:spPr>
          <a:xfrm flipH="1" flipV="1">
            <a:off x="6223000" y="1473200"/>
            <a:ext cx="4258733" cy="9313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itle 1">
            <a:extLst>
              <a:ext uri="{FF2B5EF4-FFF2-40B4-BE49-F238E27FC236}">
                <a16:creationId xmlns:a16="http://schemas.microsoft.com/office/drawing/2014/main" id="{3D2BF7F4-BC51-C046-8845-7A0DA1033A7C}"/>
              </a:ext>
            </a:extLst>
          </p:cNvPr>
          <p:cNvSpPr txBox="1">
            <a:spLocks/>
          </p:cNvSpPr>
          <p:nvPr/>
        </p:nvSpPr>
        <p:spPr>
          <a:xfrm>
            <a:off x="0" y="-88145"/>
            <a:ext cx="105156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/>
              <a:t>Supplemental Figure 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4ED3A8D-81C1-6B46-86C1-C62DE76DB558}"/>
              </a:ext>
            </a:extLst>
          </p:cNvPr>
          <p:cNvSpPr txBox="1"/>
          <p:nvPr/>
        </p:nvSpPr>
        <p:spPr>
          <a:xfrm>
            <a:off x="1393227" y="326653"/>
            <a:ext cx="494906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lected biological pathways that differ by gender for samples &lt; 60 day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471235-96D8-0347-A2E0-0F0F14E27108}"/>
              </a:ext>
            </a:extLst>
          </p:cNvPr>
          <p:cNvSpPr txBox="1"/>
          <p:nvPr/>
        </p:nvSpPr>
        <p:spPr>
          <a:xfrm>
            <a:off x="7445696" y="873166"/>
            <a:ext cx="1203767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male samples &lt; 60 days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824B402-E109-A641-8C38-AC6F106F4B65}"/>
              </a:ext>
            </a:extLst>
          </p:cNvPr>
          <p:cNvSpPr txBox="1"/>
          <p:nvPr/>
        </p:nvSpPr>
        <p:spPr>
          <a:xfrm>
            <a:off x="10671137" y="1073221"/>
            <a:ext cx="104000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le samples &lt; 60 days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42238F7-C3C6-3149-B706-63D80CC1F36F}"/>
              </a:ext>
            </a:extLst>
          </p:cNvPr>
          <p:cNvSpPr txBox="1"/>
          <p:nvPr/>
        </p:nvSpPr>
        <p:spPr>
          <a:xfrm>
            <a:off x="6770011" y="3368395"/>
            <a:ext cx="542198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ological pathways common to males and females before 60 days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E86FA7D-CFFA-4D5B-A3F4-BCD4F68D53AA}"/>
              </a:ext>
            </a:extLst>
          </p:cNvPr>
          <p:cNvCxnSpPr/>
          <p:nvPr/>
        </p:nvCxnSpPr>
        <p:spPr>
          <a:xfrm flipH="1" flipV="1">
            <a:off x="3589867" y="1066800"/>
            <a:ext cx="5511800" cy="1778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B5586AC-B42A-437F-9323-3E4C25E29170}"/>
              </a:ext>
            </a:extLst>
          </p:cNvPr>
          <p:cNvCxnSpPr/>
          <p:nvPr/>
        </p:nvCxnSpPr>
        <p:spPr>
          <a:xfrm>
            <a:off x="9958883" y="2184400"/>
            <a:ext cx="0" cy="12446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33923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4</cp:revision>
  <dcterms:created xsi:type="dcterms:W3CDTF">2022-05-12T17:09:25Z</dcterms:created>
  <dcterms:modified xsi:type="dcterms:W3CDTF">2022-05-12T17:11:06Z</dcterms:modified>
</cp:coreProperties>
</file>